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8A7677-523E-4076-B37B-AEE438D875A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FFD255-0DFE-42EF-B468-3EF1A98BA4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D25F5A-031C-4139-8E52-30DC17A1CE5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050910-D6D2-481A-BB42-3A7E681B9D3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B9BA53-9705-4529-819E-98088333CA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79CF27-24E9-425F-9EBC-0E6998B21F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A57361-10BB-454D-AAD7-0C034267E1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6CDEBD-DB8D-4E6F-9D49-D4A4A8C979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AAD8B4-E9D5-4960-9B40-A042022D53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B14BC5-7D35-4339-817E-9F37A939BF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1B2CE5-821E-4D93-8544-DA2976A48C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A6E8E1-53E0-4A00-995C-9D046A9FD7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6F732DC-C55E-4A23-A84F-4A94CA9A3F43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A0418DA-4833-400A-A8B3-5AB945C555B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1251000" y="380880"/>
            <a:ext cx="6764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upplemental figure 1. GO classification of differentially expressed gene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9" descr=""/>
          <p:cNvPicPr/>
          <p:nvPr/>
        </p:nvPicPr>
        <p:blipFill>
          <a:blip r:embed="rId1">
            <a:lum bright="-30000"/>
          </a:blip>
          <a:stretch/>
        </p:blipFill>
        <p:spPr>
          <a:xfrm>
            <a:off x="824040" y="838080"/>
            <a:ext cx="7396200" cy="5639040"/>
          </a:xfrm>
          <a:prstGeom prst="rect">
            <a:avLst/>
          </a:prstGeom>
          <a:ln w="0">
            <a:noFill/>
          </a:ln>
        </p:spPr>
      </p:pic>
      <p:sp>
        <p:nvSpPr>
          <p:cNvPr id="43" name="TextBox 3"/>
          <p:cNvSpPr/>
          <p:nvPr/>
        </p:nvSpPr>
        <p:spPr>
          <a:xfrm>
            <a:off x="4202280" y="6095880"/>
            <a:ext cx="235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Number of Transcript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4"/>
          <p:cNvSpPr/>
          <p:nvPr/>
        </p:nvSpPr>
        <p:spPr>
          <a:xfrm rot="16200000">
            <a:off x="334080" y="3181680"/>
            <a:ext cx="1497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assifica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7" descr=""/>
          <p:cNvPicPr/>
          <p:nvPr/>
        </p:nvPicPr>
        <p:blipFill>
          <a:blip r:embed="rId1"/>
          <a:stretch/>
        </p:blipFill>
        <p:spPr>
          <a:xfrm>
            <a:off x="1981080" y="1600200"/>
            <a:ext cx="5469120" cy="4113360"/>
          </a:xfrm>
          <a:prstGeom prst="rect">
            <a:avLst/>
          </a:prstGeom>
          <a:ln w="0">
            <a:noFill/>
          </a:ln>
        </p:spPr>
      </p:pic>
      <p:sp>
        <p:nvSpPr>
          <p:cNvPr id="46" name="TextBox 6"/>
          <p:cNvSpPr/>
          <p:nvPr/>
        </p:nvSpPr>
        <p:spPr>
          <a:xfrm rot="16200000">
            <a:off x="30960" y="3260880"/>
            <a:ext cx="377892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ormalized Counts [log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] Globin-Reduce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7"/>
          <p:cNvSpPr/>
          <p:nvPr/>
        </p:nvSpPr>
        <p:spPr>
          <a:xfrm>
            <a:off x="3633120" y="5715000"/>
            <a:ext cx="235548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ormalized Counts [log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Arial"/>
              </a:rPr>
              <a:t>10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]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8"/>
          <p:cNvSpPr/>
          <p:nvPr/>
        </p:nvSpPr>
        <p:spPr>
          <a:xfrm>
            <a:off x="2590920" y="1752480"/>
            <a:ext cx="1218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R</a:t>
            </a:r>
            <a:r>
              <a:rPr b="1" lang="en-US" sz="2400" spc="-1" strike="noStrike" baseline="30000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= 0.93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5"/>
          <p:cNvSpPr/>
          <p:nvPr/>
        </p:nvSpPr>
        <p:spPr>
          <a:xfrm>
            <a:off x="1311480" y="533520"/>
            <a:ext cx="247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ur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09T13:50:29Z</dcterms:created>
  <dc:creator>Nalini Raghavachari</dc:creator>
  <dc:description/>
  <dc:language>en-US</dc:language>
  <cp:lastModifiedBy>Nalini Raghavachari</cp:lastModifiedBy>
  <dcterms:modified xsi:type="dcterms:W3CDTF">2011-11-04T19:29:54Z</dcterms:modified>
  <cp:revision>142</cp:revision>
  <dc:subject/>
  <dc:title>Figures and Tables for RNAseq vs exon array comaprison</dc:title>
</cp:coreProperties>
</file>